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2" r:id="rId3"/>
    <p:sldId id="259" r:id="rId4"/>
    <p:sldId id="260" r:id="rId5"/>
    <p:sldId id="261" r:id="rId6"/>
    <p:sldId id="262" r:id="rId7"/>
    <p:sldId id="263" r:id="rId8"/>
    <p:sldId id="264" r:id="rId9"/>
    <p:sldId id="281" r:id="rId10"/>
    <p:sldId id="282" r:id="rId11"/>
    <p:sldId id="283" r:id="rId12"/>
    <p:sldId id="284" r:id="rId13"/>
    <p:sldId id="285" r:id="rId14"/>
    <p:sldId id="286" r:id="rId15"/>
    <p:sldId id="287" r:id="rId16"/>
    <p:sldId id="273" r:id="rId17"/>
    <p:sldId id="265" r:id="rId18"/>
    <p:sldId id="266" r:id="rId19"/>
    <p:sldId id="267" r:id="rId20"/>
    <p:sldId id="268" r:id="rId21"/>
    <p:sldId id="269" r:id="rId22"/>
    <p:sldId id="270" r:id="rId23"/>
    <p:sldId id="274" r:id="rId24"/>
    <p:sldId id="275" r:id="rId25"/>
    <p:sldId id="276" r:id="rId26"/>
    <p:sldId id="277" r:id="rId27"/>
    <p:sldId id="278" r:id="rId28"/>
    <p:sldId id="279" r:id="rId29"/>
    <p:sldId id="280" r:id="rId30"/>
    <p:sldId id="288" r:id="rId31"/>
    <p:sldId id="289" r:id="rId32"/>
    <p:sldId id="290" r:id="rId33"/>
    <p:sldId id="291" r:id="rId34"/>
    <p:sldId id="292" r:id="rId35"/>
    <p:sldId id="293" r:id="rId36"/>
    <p:sldId id="294" r:id="rId37"/>
    <p:sldId id="295" r:id="rId38"/>
    <p:sldId id="296" r:id="rId39"/>
    <p:sldId id="297" r:id="rId40"/>
    <p:sldId id="298" r:id="rId41"/>
    <p:sldId id="299" r:id="rId42"/>
    <p:sldId id="300" r:id="rId43"/>
    <p:sldId id="301" r:id="rId44"/>
    <p:sldId id="302" r:id="rId45"/>
    <p:sldId id="303" r:id="rId46"/>
    <p:sldId id="304" r:id="rId47"/>
    <p:sldId id="305" r:id="rId48"/>
    <p:sldId id="306" r:id="rId49"/>
    <p:sldId id="307" r:id="rId50"/>
    <p:sldId id="308" r:id="rId51"/>
    <p:sldId id="309" r:id="rId52"/>
    <p:sldId id="310" r:id="rId53"/>
    <p:sldId id="311" r:id="rId54"/>
    <p:sldId id="312" r:id="rId55"/>
    <p:sldId id="313" r:id="rId56"/>
    <p:sldId id="314" r:id="rId57"/>
    <p:sldId id="315" r:id="rId58"/>
  </p:sldIdLst>
  <p:sldSz cx="12192000" cy="6858000"/>
  <p:notesSz cx="6858000" cy="9144000"/>
  <p:custDataLst>
    <p:tags r:id="rId59"/>
  </p:custDataLst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43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63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61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19CC6-65E0-4DE8-9967-65248816E0EA}" type="datetimeFigureOut">
              <a:rPr lang="fr-FR" smtClean="0"/>
              <a:t>03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26905-2C59-48F7-BBAB-163D9782E8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5079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19CC6-65E0-4DE8-9967-65248816E0EA}" type="datetimeFigureOut">
              <a:rPr lang="fr-FR" smtClean="0"/>
              <a:t>03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26905-2C59-48F7-BBAB-163D9782E8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587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19CC6-65E0-4DE8-9967-65248816E0EA}" type="datetimeFigureOut">
              <a:rPr lang="fr-FR" smtClean="0"/>
              <a:t>03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26905-2C59-48F7-BBAB-163D9782E8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8626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19CC6-65E0-4DE8-9967-65248816E0EA}" type="datetimeFigureOut">
              <a:rPr lang="fr-FR" smtClean="0"/>
              <a:t>03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26905-2C59-48F7-BBAB-163D9782E8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3357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19CC6-65E0-4DE8-9967-65248816E0EA}" type="datetimeFigureOut">
              <a:rPr lang="fr-FR" smtClean="0"/>
              <a:t>03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26905-2C59-48F7-BBAB-163D9782E8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05476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19CC6-65E0-4DE8-9967-65248816E0EA}" type="datetimeFigureOut">
              <a:rPr lang="fr-FR" smtClean="0"/>
              <a:t>03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26905-2C59-48F7-BBAB-163D9782E8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2835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19CC6-65E0-4DE8-9967-65248816E0EA}" type="datetimeFigureOut">
              <a:rPr lang="fr-FR" smtClean="0"/>
              <a:t>03/07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26905-2C59-48F7-BBAB-163D9782E8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2144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19CC6-65E0-4DE8-9967-65248816E0EA}" type="datetimeFigureOut">
              <a:rPr lang="fr-FR" smtClean="0"/>
              <a:t>03/07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26905-2C59-48F7-BBAB-163D9782E8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18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19CC6-65E0-4DE8-9967-65248816E0EA}" type="datetimeFigureOut">
              <a:rPr lang="fr-FR" smtClean="0"/>
              <a:t>03/07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26905-2C59-48F7-BBAB-163D9782E8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08822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19CC6-65E0-4DE8-9967-65248816E0EA}" type="datetimeFigureOut">
              <a:rPr lang="fr-FR" smtClean="0"/>
              <a:t>03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26905-2C59-48F7-BBAB-163D9782E8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9793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19CC6-65E0-4DE8-9967-65248816E0EA}" type="datetimeFigureOut">
              <a:rPr lang="fr-FR" smtClean="0"/>
              <a:t>03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26905-2C59-48F7-BBAB-163D9782E8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9206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319CC6-65E0-4DE8-9967-65248816E0EA}" type="datetimeFigureOut">
              <a:rPr lang="fr-FR" smtClean="0"/>
              <a:t>03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A26905-2C59-48F7-BBAB-163D9782E8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1226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png"/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png"/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png"/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2.xml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2.png"/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2.xml"/></Relationships>
</file>

<file path=ppt/slides/_rels/slide4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png"/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2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2.xml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png"/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2.xml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png"/><Relationship Id="rId2" Type="http://schemas.openxmlformats.org/officeDocument/2006/relationships/image" Target="../media/image78.png"/><Relationship Id="rId1" Type="http://schemas.openxmlformats.org/officeDocument/2006/relationships/slideLayout" Target="../slideLayouts/slideLayout2.xml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png"/><Relationship Id="rId2" Type="http://schemas.openxmlformats.org/officeDocument/2006/relationships/image" Target="../media/image8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3.png"/><Relationship Id="rId2" Type="http://schemas.openxmlformats.org/officeDocument/2006/relationships/image" Target="../media/image82.png"/><Relationship Id="rId1" Type="http://schemas.openxmlformats.org/officeDocument/2006/relationships/slideLayout" Target="../slideLayouts/slideLayout2.xml"/></Relationships>
</file>

<file path=ppt/slides/_rels/slide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5.png"/><Relationship Id="rId2" Type="http://schemas.openxmlformats.org/officeDocument/2006/relationships/image" Target="../media/image84.png"/><Relationship Id="rId1" Type="http://schemas.openxmlformats.org/officeDocument/2006/relationships/slideLayout" Target="../slideLayouts/slideLayout2.xml"/></Relationships>
</file>

<file path=ppt/slides/_rels/slide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7.png"/><Relationship Id="rId2" Type="http://schemas.openxmlformats.org/officeDocument/2006/relationships/image" Target="../media/image86.png"/><Relationship Id="rId1" Type="http://schemas.openxmlformats.org/officeDocument/2006/relationships/slideLayout" Target="../slideLayouts/slideLayout2.xml"/></Relationships>
</file>

<file path=ppt/slides/_rels/slide5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png"/><Relationship Id="rId2" Type="http://schemas.openxmlformats.org/officeDocument/2006/relationships/image" Target="../media/image88.png"/><Relationship Id="rId1" Type="http://schemas.openxmlformats.org/officeDocument/2006/relationships/slideLayout" Target="../slideLayouts/slideLayout2.xml"/></Relationships>
</file>

<file path=ppt/slides/_rels/slide5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1.png"/><Relationship Id="rId2" Type="http://schemas.openxmlformats.org/officeDocument/2006/relationships/image" Target="../media/image90.png"/><Relationship Id="rId1" Type="http://schemas.openxmlformats.org/officeDocument/2006/relationships/slideLayout" Target="../slideLayouts/slideLayout2.xml"/></Relationships>
</file>

<file path=ppt/slides/_rels/slide5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3.png"/><Relationship Id="rId2" Type="http://schemas.openxmlformats.org/officeDocument/2006/relationships/image" Target="../media/image92.png"/><Relationship Id="rId1" Type="http://schemas.openxmlformats.org/officeDocument/2006/relationships/slideLayout" Target="../slideLayouts/slideLayout2.xml"/></Relationships>
</file>

<file path=ppt/slides/_rels/slide5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5.png"/><Relationship Id="rId2" Type="http://schemas.openxmlformats.org/officeDocument/2006/relationships/image" Target="../media/image9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fr-FR" dirty="0" smtClean="0"/>
              <a:t>Biopsies </a:t>
            </a:r>
            <a:r>
              <a:rPr lang="fr-FR" dirty="0" err="1" smtClean="0"/>
              <a:t>gating</a:t>
            </a:r>
            <a:r>
              <a:rPr lang="fr-FR" dirty="0" smtClean="0"/>
              <a:t> </a:t>
            </a:r>
            <a:r>
              <a:rPr lang="fr-FR" dirty="0" err="1" smtClean="0"/>
              <a:t>analysi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6043476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</a:t>
            </a:r>
            <a:r>
              <a:rPr lang="fr-FR" dirty="0"/>
              <a:t>3</a:t>
            </a:r>
            <a:r>
              <a:rPr lang="fr-FR" dirty="0" smtClean="0"/>
              <a:t>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207962" y="1238243"/>
            <a:ext cx="445956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NT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216000" y="4176000"/>
            <a:ext cx="104067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MK-1775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62162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62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783385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208800" y="1238400"/>
            <a:ext cx="114807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PD166285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16000" y="4176000"/>
            <a:ext cx="307424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1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3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62162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62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352370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3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3965509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4143442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62162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62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623049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3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278409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379078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62162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62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416343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</a:t>
            </a:r>
            <a:r>
              <a:rPr lang="fr-FR" dirty="0"/>
              <a:t>3</a:t>
            </a:r>
            <a:r>
              <a:rPr lang="fr-FR" dirty="0" smtClean="0"/>
              <a:t>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08800" y="1238400"/>
            <a:ext cx="396871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>
            <a:off x="216000" y="4176000"/>
            <a:ext cx="278409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62162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62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624598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3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379078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396871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62162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62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739861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8200" y="2766219"/>
            <a:ext cx="10515600" cy="1325563"/>
          </a:xfrm>
        </p:spPr>
        <p:txBody>
          <a:bodyPr/>
          <a:lstStyle/>
          <a:p>
            <a:pPr algn="ctr"/>
            <a:r>
              <a:rPr lang="fr-FR" dirty="0" smtClean="0"/>
              <a:t>FL4: DAY 1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6586566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4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207962" y="1238243"/>
            <a:ext cx="445956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NT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216000" y="4176000"/>
            <a:ext cx="104067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MK-1775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701526"/>
            <a:ext cx="11520000" cy="1630511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6305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966228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208800" y="1238400"/>
            <a:ext cx="114807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PD166285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16000" y="4176000"/>
            <a:ext cx="307424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1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4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630511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6305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464067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4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3965509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4143442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630511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6305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13595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8200" y="2766219"/>
            <a:ext cx="10515600" cy="1325563"/>
          </a:xfrm>
        </p:spPr>
        <p:txBody>
          <a:bodyPr/>
          <a:lstStyle/>
          <a:p>
            <a:pPr algn="ctr"/>
            <a:r>
              <a:rPr lang="fr-FR" dirty="0" smtClean="0"/>
              <a:t>FL3: DAY 1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165355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4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278409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379078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630511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6305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207817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4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08800" y="1238400"/>
            <a:ext cx="396871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>
            <a:off x="216000" y="4176000"/>
            <a:ext cx="278409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630511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6305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125781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4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379078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396871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630511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6305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878214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8200" y="2766219"/>
            <a:ext cx="10515600" cy="1325563"/>
          </a:xfrm>
        </p:spPr>
        <p:txBody>
          <a:bodyPr/>
          <a:lstStyle/>
          <a:p>
            <a:pPr algn="ctr"/>
            <a:r>
              <a:rPr lang="fr-FR" dirty="0" smtClean="0"/>
              <a:t>FL4: DAY 4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892172644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4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207962" y="1238243"/>
            <a:ext cx="445956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NT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216000" y="4176000"/>
            <a:ext cx="104067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MK-1775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66781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66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372545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208800" y="1238400"/>
            <a:ext cx="114807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PD166285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16000" y="4176000"/>
            <a:ext cx="307424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1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4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66781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66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6367389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4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3965509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4143442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66781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66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4744888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4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278409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379078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66781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66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8163026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4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08800" y="1238400"/>
            <a:ext cx="396871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>
            <a:off x="216000" y="4176000"/>
            <a:ext cx="278409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66781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66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8680842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4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379078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396871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66781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66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85358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3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207962" y="1238243"/>
            <a:ext cx="445956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NT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216000" y="4176000"/>
            <a:ext cx="104067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MK-1775</a:t>
            </a:r>
            <a:endParaRPr lang="fr-FR" dirty="0"/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4680000"/>
            <a:ext cx="11520000" cy="1975675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1656000"/>
            <a:ext cx="11520000" cy="19880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6032027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8200" y="2766219"/>
            <a:ext cx="10515600" cy="1325563"/>
          </a:xfrm>
        </p:spPr>
        <p:txBody>
          <a:bodyPr/>
          <a:lstStyle/>
          <a:p>
            <a:pPr algn="ctr"/>
            <a:r>
              <a:rPr lang="fr-FR" dirty="0" smtClean="0"/>
              <a:t>DLBCL 1: DAY 1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770031695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DLBCL 1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207962" y="1238243"/>
            <a:ext cx="445956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NT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216000" y="4176000"/>
            <a:ext cx="104067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MK-1775</a:t>
            </a:r>
            <a:endParaRPr lang="fr-FR" dirty="0"/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92414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92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4077148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208800" y="1238400"/>
            <a:ext cx="114807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PD166285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16000" y="4176000"/>
            <a:ext cx="307424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1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DLBCL 1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92414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92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5427546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/>
              <a:t>DLBCL </a:t>
            </a:r>
            <a:r>
              <a:rPr lang="fr-FR" dirty="0" smtClean="0"/>
              <a:t>1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3965509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4143442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92414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92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7706371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/>
              <a:t>DLBCL </a:t>
            </a:r>
            <a:r>
              <a:rPr lang="fr-FR" dirty="0" smtClean="0"/>
              <a:t>1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278409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379078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92414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92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0908320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/>
              <a:t>DLBCL </a:t>
            </a:r>
            <a:r>
              <a:rPr lang="fr-FR" dirty="0" smtClean="0"/>
              <a:t>1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08800" y="1238400"/>
            <a:ext cx="396871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>
            <a:off x="216000" y="4176000"/>
            <a:ext cx="278409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92414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92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8018390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/>
              <a:t>DLBCL </a:t>
            </a:r>
            <a:r>
              <a:rPr lang="fr-FR" dirty="0" smtClean="0"/>
              <a:t>1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379078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396871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92414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92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321682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8200" y="2766219"/>
            <a:ext cx="10515600" cy="1325563"/>
          </a:xfrm>
        </p:spPr>
        <p:txBody>
          <a:bodyPr/>
          <a:lstStyle/>
          <a:p>
            <a:pPr algn="ctr"/>
            <a:r>
              <a:rPr lang="fr-FR" dirty="0" smtClean="0"/>
              <a:t>DLBCL 1: DAY 4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246282818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DLBCL 1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207962" y="1238243"/>
            <a:ext cx="445956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NT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216000" y="4176000"/>
            <a:ext cx="104067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MK-1775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83571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835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6403675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208800" y="1238400"/>
            <a:ext cx="114807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PD166285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16000" y="4176000"/>
            <a:ext cx="307424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1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DLBCL 1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83571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835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76221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208800" y="1238400"/>
            <a:ext cx="114807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PD166285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16000" y="4176000"/>
            <a:ext cx="307424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pic>
        <p:nvPicPr>
          <p:cNvPr id="9" name="Imag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4680000"/>
            <a:ext cx="11520000" cy="1920000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1656000"/>
            <a:ext cx="11520000" cy="1920000"/>
          </a:xfrm>
          <a:prstGeom prst="rect">
            <a:avLst/>
          </a:prstGeom>
        </p:spPr>
      </p:pic>
      <p:sp>
        <p:nvSpPr>
          <p:cNvPr id="1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3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34705502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/>
              <a:t>DLBCL </a:t>
            </a:r>
            <a:r>
              <a:rPr lang="fr-FR" dirty="0" smtClean="0"/>
              <a:t>1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3965509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4143442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83571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835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8372350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/>
              <a:t>DLBCL </a:t>
            </a:r>
            <a:r>
              <a:rPr lang="fr-FR" dirty="0" smtClean="0"/>
              <a:t>1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278409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379078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83571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835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4645496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/>
              <a:t>DLBCL </a:t>
            </a:r>
            <a:r>
              <a:rPr lang="fr-FR" dirty="0" smtClean="0"/>
              <a:t>1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08800" y="1238400"/>
            <a:ext cx="396871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>
            <a:off x="216000" y="4176000"/>
            <a:ext cx="278409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83571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835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9201052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/>
              <a:t>DLBCL </a:t>
            </a:r>
            <a:r>
              <a:rPr lang="fr-FR" dirty="0" smtClean="0"/>
              <a:t>1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379078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396871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83571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835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0020346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8200" y="2766219"/>
            <a:ext cx="10515600" cy="1325563"/>
          </a:xfrm>
        </p:spPr>
        <p:txBody>
          <a:bodyPr/>
          <a:lstStyle/>
          <a:p>
            <a:pPr algn="ctr"/>
            <a:r>
              <a:rPr lang="fr-FR" dirty="0" smtClean="0"/>
              <a:t>DLBCL 6: DAY 1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75289032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DLBCL 6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207962" y="1238243"/>
            <a:ext cx="445956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NT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216000" y="4176000"/>
            <a:ext cx="104067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MK-1775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85043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850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1777532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208800" y="1238400"/>
            <a:ext cx="114807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PD166285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16000" y="4176000"/>
            <a:ext cx="307424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1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DLBCL 6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85043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4680000"/>
            <a:ext cx="11520000" cy="15850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5251957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/>
              <a:t>DLBCL </a:t>
            </a:r>
            <a:r>
              <a:rPr lang="fr-FR" dirty="0" smtClean="0"/>
              <a:t>6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3965509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4143442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85043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850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2659305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/>
              <a:t>DLBCL 6</a:t>
            </a:r>
            <a:r>
              <a:rPr lang="fr-FR" dirty="0" smtClean="0"/>
              <a:t>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278409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379078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85043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850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2168424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/>
              <a:t>DLBCL 6</a:t>
            </a:r>
            <a:r>
              <a:rPr lang="fr-FR" dirty="0" smtClean="0"/>
              <a:t>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08800" y="1238400"/>
            <a:ext cx="396871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>
            <a:off x="216000" y="4176000"/>
            <a:ext cx="278409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85043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850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68965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3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3965509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4143442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4680000"/>
            <a:ext cx="11520000" cy="1920000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1656000"/>
            <a:ext cx="11520000" cy="19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8241329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/>
              <a:t>DLBCL 6</a:t>
            </a:r>
            <a:r>
              <a:rPr lang="fr-FR" dirty="0" smtClean="0"/>
              <a:t>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379078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396871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85043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850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2332908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8200" y="2766219"/>
            <a:ext cx="10515600" cy="1325563"/>
          </a:xfrm>
        </p:spPr>
        <p:txBody>
          <a:bodyPr/>
          <a:lstStyle/>
          <a:p>
            <a:pPr algn="ctr"/>
            <a:r>
              <a:rPr lang="fr-FR" dirty="0" smtClean="0"/>
              <a:t>DLBCL 6: DAY 4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05552076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DLBCL 6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207962" y="1238243"/>
            <a:ext cx="445956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NT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216000" y="4176000"/>
            <a:ext cx="104067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MK-1775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75222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752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7327445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208800" y="1238400"/>
            <a:ext cx="114807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PD166285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16000" y="4176000"/>
            <a:ext cx="307424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1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DLBCL 6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75222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752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7661324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/>
              <a:t>DLBCL </a:t>
            </a:r>
            <a:r>
              <a:rPr lang="fr-FR" dirty="0" smtClean="0"/>
              <a:t>6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3965509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4143442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75222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752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545704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/>
              <a:t>DLBCL 6</a:t>
            </a:r>
            <a:r>
              <a:rPr lang="fr-FR" dirty="0" smtClean="0"/>
              <a:t>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278409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379078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75222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752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4897282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/>
              <a:t>DLBCL 6</a:t>
            </a:r>
            <a:r>
              <a:rPr lang="fr-FR" dirty="0" smtClean="0"/>
              <a:t>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08800" y="1238400"/>
            <a:ext cx="396871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>
            <a:off x="216000" y="4176000"/>
            <a:ext cx="278409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75222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752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4172497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/>
              <a:t>DLBCL 6</a:t>
            </a:r>
            <a:r>
              <a:rPr lang="fr-FR" dirty="0" smtClean="0"/>
              <a:t>: </a:t>
            </a:r>
            <a:r>
              <a:rPr lang="fr-FR" dirty="0" err="1" smtClean="0"/>
              <a:t>day</a:t>
            </a:r>
            <a:r>
              <a:rPr lang="fr-FR" dirty="0" smtClean="0"/>
              <a:t> 4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379078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396871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656000"/>
            <a:ext cx="11520000" cy="1575222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4680000"/>
            <a:ext cx="11520000" cy="15752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34420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3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278409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379078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4680000"/>
            <a:ext cx="11520000" cy="1920000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1656000"/>
            <a:ext cx="11520000" cy="19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856540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3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08800" y="1238400"/>
            <a:ext cx="396871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>
            <a:off x="216000" y="4176000"/>
            <a:ext cx="278409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4680000"/>
            <a:ext cx="11520000" cy="1920000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1656000"/>
            <a:ext cx="11520000" cy="19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66826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FL 3: </a:t>
            </a:r>
            <a:r>
              <a:rPr lang="fr-FR" dirty="0" err="1" smtClean="0"/>
              <a:t>day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208800" y="1238400"/>
            <a:ext cx="379078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MK1775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16000" y="4176000"/>
            <a:ext cx="3968715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+ PD166285</a:t>
            </a:r>
            <a:endParaRPr lang="fr-FR" dirty="0"/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4680000"/>
            <a:ext cx="11520000" cy="1906187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00" y="1656000"/>
            <a:ext cx="11520000" cy="19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860048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8200" y="2766219"/>
            <a:ext cx="10515600" cy="1325563"/>
          </a:xfrm>
        </p:spPr>
        <p:txBody>
          <a:bodyPr/>
          <a:lstStyle/>
          <a:p>
            <a:pPr algn="ctr"/>
            <a:r>
              <a:rPr lang="fr-FR" dirty="0" smtClean="0"/>
              <a:t>FL3: DAY 4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477122079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4" val="RXP"/>
  <p:tag name="VARPPTCOMPATIBLERD03" val="RXP"/>
  <p:tag name="VARPPTTYPE" val="RXP"/>
  <p:tag name="VARPPTSLIDEFORMAT" val="RXP"/>
  <p:tag name="VARSAVEMESSAGETIMESTAMP" val="RXP27/06/2019"/>
</p:tagLst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59</Words>
  <Application>Microsoft Office PowerPoint</Application>
  <PresentationFormat>Grand écran</PresentationFormat>
  <Paragraphs>153</Paragraphs>
  <Slides>57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7</vt:i4>
      </vt:variant>
    </vt:vector>
  </HeadingPairs>
  <TitlesOfParts>
    <vt:vector size="61" baseType="lpstr">
      <vt:lpstr>Arial</vt:lpstr>
      <vt:lpstr>Calibri</vt:lpstr>
      <vt:lpstr>Calibri Light</vt:lpstr>
      <vt:lpstr>Thème Office</vt:lpstr>
      <vt:lpstr>Biopsies gating analysis</vt:lpstr>
      <vt:lpstr>FL3: DAY 1</vt:lpstr>
      <vt:lpstr>FL 3: day 1</vt:lpstr>
      <vt:lpstr>FL 3: day 1</vt:lpstr>
      <vt:lpstr>FL 3: day 1</vt:lpstr>
      <vt:lpstr>FL 3: day 1</vt:lpstr>
      <vt:lpstr>FL 3: day 1</vt:lpstr>
      <vt:lpstr>FL 3: day 1</vt:lpstr>
      <vt:lpstr>FL3: DAY 4</vt:lpstr>
      <vt:lpstr>FL 3: day 4</vt:lpstr>
      <vt:lpstr>FL 3: day 4</vt:lpstr>
      <vt:lpstr>FL 3: day 4</vt:lpstr>
      <vt:lpstr>FL 3: day 4</vt:lpstr>
      <vt:lpstr>FL 3: day 4</vt:lpstr>
      <vt:lpstr>FL 3: day 4</vt:lpstr>
      <vt:lpstr>FL4: DAY 1</vt:lpstr>
      <vt:lpstr>FL 4: day 1</vt:lpstr>
      <vt:lpstr>FL 4: day 1</vt:lpstr>
      <vt:lpstr>FL 4: day 1</vt:lpstr>
      <vt:lpstr>FL 4: day 1</vt:lpstr>
      <vt:lpstr>FL 4: day 1</vt:lpstr>
      <vt:lpstr>FL 4: day 1</vt:lpstr>
      <vt:lpstr>FL4: DAY 4</vt:lpstr>
      <vt:lpstr>FL 4: day 4</vt:lpstr>
      <vt:lpstr>FL 4: day 4</vt:lpstr>
      <vt:lpstr>FL 4: day 4</vt:lpstr>
      <vt:lpstr>FL 4: day 4</vt:lpstr>
      <vt:lpstr>FL 4: day 4</vt:lpstr>
      <vt:lpstr>FL 4: day 4</vt:lpstr>
      <vt:lpstr>DLBCL 1: DAY 1</vt:lpstr>
      <vt:lpstr>DLBCL 1: day 1</vt:lpstr>
      <vt:lpstr>DLBCL 1: day 1</vt:lpstr>
      <vt:lpstr>DLBCL 1: day 1</vt:lpstr>
      <vt:lpstr>DLBCL 1: day 1</vt:lpstr>
      <vt:lpstr>DLBCL 1: day 1</vt:lpstr>
      <vt:lpstr>DLBCL 1: day 1</vt:lpstr>
      <vt:lpstr>DLBCL 1: DAY 4</vt:lpstr>
      <vt:lpstr>DLBCL 1: day 4</vt:lpstr>
      <vt:lpstr>DLBCL 1: day 4</vt:lpstr>
      <vt:lpstr>DLBCL 1: day 4</vt:lpstr>
      <vt:lpstr>DLBCL 1: day 4</vt:lpstr>
      <vt:lpstr>DLBCL 1: day 4</vt:lpstr>
      <vt:lpstr>DLBCL 1: day 4</vt:lpstr>
      <vt:lpstr>DLBCL 6: DAY 1</vt:lpstr>
      <vt:lpstr>DLBCL 6: day 1</vt:lpstr>
      <vt:lpstr>DLBCL 6: day 1</vt:lpstr>
      <vt:lpstr>DLBCL 6: day 1</vt:lpstr>
      <vt:lpstr>DLBCL 6: day 1</vt:lpstr>
      <vt:lpstr>DLBCL 6: day 1</vt:lpstr>
      <vt:lpstr>DLBCL 6: day 1</vt:lpstr>
      <vt:lpstr>DLBCL 6: DAY 4</vt:lpstr>
      <vt:lpstr>DLBCL 6: day 4</vt:lpstr>
      <vt:lpstr>DLBCL 6: day 4</vt:lpstr>
      <vt:lpstr>DLBCL 6: day 4</vt:lpstr>
      <vt:lpstr>DLBCL 6: day 4</vt:lpstr>
      <vt:lpstr>DLBCL 6: day 4</vt:lpstr>
      <vt:lpstr>DLBCL 6: day 4</vt:lpstr>
    </vt:vector>
  </TitlesOfParts>
  <Company>F. Hoffmann-La Roche, Ltd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chard, Alexandre {PORB~Boulogne-Billancourt}</dc:creator>
  <cp:lastModifiedBy>Pouget Jean-Pierre</cp:lastModifiedBy>
  <cp:revision>40</cp:revision>
  <dcterms:created xsi:type="dcterms:W3CDTF">2019-06-23T14:10:51Z</dcterms:created>
  <dcterms:modified xsi:type="dcterms:W3CDTF">2019-07-03T08:53:21Z</dcterms:modified>
</cp:coreProperties>
</file>